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3208000" cy="990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4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2" d="100"/>
          <a:sy n="52" d="100"/>
        </p:scale>
        <p:origin x="1296" y="78"/>
      </p:cViewPr>
      <p:guideLst>
        <p:guide orient="horz" pos="3120"/>
        <p:guide pos="4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225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06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497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120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03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818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135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409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99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629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56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3B91E-E1AF-4448-96A8-B9672FA795C1}" type="datetimeFigureOut">
              <a:rPr lang="en-US" smtClean="0"/>
              <a:t>2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5C7E8-2AE4-466A-9DD4-96418E2C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174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9528" y="3714750"/>
            <a:ext cx="31172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neffective empirical regimen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DDs =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54422" y="5010150"/>
            <a:ext cx="21275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ffective regimen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00 (7×100)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2256876" y="3890868"/>
            <a:ext cx="2274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ntinued treatmen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229479" y="3028950"/>
            <a:ext cx="229203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continued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until Day 14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00 (7×100)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281339" y="6800850"/>
            <a:ext cx="211250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stopped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t Day 7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0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285275" y="6397688"/>
            <a:ext cx="2253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runcated treatmen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696630" y="4000500"/>
            <a:ext cx="21804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Retreatment 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%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0 (5×14)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738820" y="2190750"/>
            <a:ext cx="24929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o retreatment in 95%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0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729119" y="7829550"/>
            <a:ext cx="23086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Retreatment 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0%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280 (20×14)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738820" y="6019800"/>
            <a:ext cx="24929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o retreatment in 80%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0 DDD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9303131" y="3200400"/>
            <a:ext cx="2745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otal DDDs = 1470 +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9284081" y="7067550"/>
            <a:ext cx="2616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otal DDDs = 980 +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ight Brace 21"/>
          <p:cNvSpPr/>
          <p:nvPr/>
        </p:nvSpPr>
        <p:spPr>
          <a:xfrm>
            <a:off x="9042232" y="2152650"/>
            <a:ext cx="279949" cy="2475131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ight Brace 22"/>
          <p:cNvSpPr/>
          <p:nvPr/>
        </p:nvSpPr>
        <p:spPr>
          <a:xfrm>
            <a:off x="9023182" y="6000750"/>
            <a:ext cx="279949" cy="2475131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6534014" y="2494865"/>
            <a:ext cx="0" cy="18288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6534014" y="2504480"/>
            <a:ext cx="28588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6534014" y="4314230"/>
            <a:ext cx="28588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6534014" y="6323915"/>
            <a:ext cx="0" cy="18288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6523442" y="6326215"/>
            <a:ext cx="28588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6524489" y="8152805"/>
            <a:ext cx="28588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1409700" y="4361081"/>
            <a:ext cx="0" cy="649069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6324847" y="7209830"/>
            <a:ext cx="2091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6324847" y="3456980"/>
            <a:ext cx="2091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Elbow Connector 2"/>
          <p:cNvCxnSpPr/>
          <p:nvPr/>
        </p:nvCxnSpPr>
        <p:spPr>
          <a:xfrm>
            <a:off x="2607749" y="5428566"/>
            <a:ext cx="1964251" cy="1833949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Elbow Connector 7"/>
          <p:cNvCxnSpPr/>
          <p:nvPr/>
        </p:nvCxnSpPr>
        <p:spPr>
          <a:xfrm flipV="1">
            <a:off x="2607749" y="3474482"/>
            <a:ext cx="1907101" cy="1748314"/>
          </a:xfrm>
          <a:prstGeom prst="bentConnector3">
            <a:avLst>
              <a:gd name="adj1" fmla="val 50999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9302375" y="4871650"/>
            <a:ext cx="395492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(1470 – 980)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ifference = ------------------- = 33.3%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     1470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10858500" y="3714750"/>
            <a:ext cx="476033" cy="970865"/>
          </a:xfrm>
          <a:prstGeom prst="straightConnector1">
            <a:avLst/>
          </a:prstGeom>
          <a:ln w="1905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V="1">
            <a:off x="10820400" y="5890230"/>
            <a:ext cx="476033" cy="1005870"/>
          </a:xfrm>
          <a:prstGeom prst="straightConnector1">
            <a:avLst/>
          </a:prstGeom>
          <a:ln w="1905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603244" y="634485"/>
            <a:ext cx="193739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ay 7 of 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ffective regimen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555021" y="647312"/>
            <a:ext cx="193739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ay 14 of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ffective regimen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8015392" y="641866"/>
            <a:ext cx="233910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6 weeks  after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completion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3581400" y="1289566"/>
            <a:ext cx="0" cy="577334"/>
          </a:xfrm>
          <a:prstGeom prst="straightConnector1">
            <a:avLst/>
          </a:prstGeom>
          <a:ln>
            <a:solidFill>
              <a:schemeClr val="tx1"/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6534150" y="1289566"/>
            <a:ext cx="0" cy="577334"/>
          </a:xfrm>
          <a:prstGeom prst="straightConnector1">
            <a:avLst/>
          </a:prstGeom>
          <a:ln>
            <a:solidFill>
              <a:schemeClr val="tx1"/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9182100" y="1289566"/>
            <a:ext cx="0" cy="577334"/>
          </a:xfrm>
          <a:prstGeom prst="straightConnector1">
            <a:avLst/>
          </a:prstGeom>
          <a:ln>
            <a:solidFill>
              <a:schemeClr val="tx1"/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577918" y="908566"/>
            <a:ext cx="168507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ospitalization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>
            <a:off x="1409700" y="1289566"/>
            <a:ext cx="0" cy="577334"/>
          </a:xfrm>
          <a:prstGeom prst="straightConnector1">
            <a:avLst/>
          </a:prstGeom>
          <a:ln>
            <a:solidFill>
              <a:schemeClr val="tx1"/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59913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</TotalTime>
  <Words>106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21</cp:revision>
  <dcterms:created xsi:type="dcterms:W3CDTF">2017-12-22T14:17:26Z</dcterms:created>
  <dcterms:modified xsi:type="dcterms:W3CDTF">2018-02-19T15:01:43Z</dcterms:modified>
</cp:coreProperties>
</file>